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56B5A7F-A37F-BB7A-1E73-8685F24F4C5F}" v="6" dt="2024-01-21T20:13:40.1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52" d="100"/>
          <a:sy n="52" d="100"/>
        </p:scale>
        <p:origin x="2506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Dhakal, Alfa" userId="S::aldhakal@iu.edu::47175381-e0f0-42f2-a909-d585e2a70e98" providerId="AD" clId="Web-{213A0EB9-897A-54EB-2B0B-CB48C73BBC02}"/>
    <pc:docChg chg="modSld">
      <pc:chgData name="Dhakal, Alfa" userId="S::aldhakal@iu.edu::47175381-e0f0-42f2-a909-d585e2a70e98" providerId="AD" clId="Web-{213A0EB9-897A-54EB-2B0B-CB48C73BBC02}" dt="2023-08-04T18:36:35.030" v="1" actId="20577"/>
      <pc:docMkLst>
        <pc:docMk/>
      </pc:docMkLst>
      <pc:sldChg chg="modSp">
        <pc:chgData name="Dhakal, Alfa" userId="S::aldhakal@iu.edu::47175381-e0f0-42f2-a909-d585e2a70e98" providerId="AD" clId="Web-{213A0EB9-897A-54EB-2B0B-CB48C73BBC02}" dt="2023-08-04T18:36:35.030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213A0EB9-897A-54EB-2B0B-CB48C73BBC02}" dt="2023-08-04T18:36:35.030" v="1" actId="20577"/>
          <ac:spMkLst>
            <pc:docMk/>
            <pc:sldMk cId="4017803071" sldId="256"/>
            <ac:spMk id="4" creationId="{F5085EF0-C269-B6AE-F3C2-79DBC2C7AF92}"/>
          </ac:spMkLst>
        </pc:spChg>
      </pc:sldChg>
    </pc:docChg>
  </pc:docChgLst>
  <pc:docChgLst>
    <pc:chgData name="Salim, Chinnu" userId="S::chisalim@iu.edu::97f0121d-12bb-4de1-b0c3-9497d3c11a4c" providerId="AD" clId="Web-{056B5A7F-A37F-BB7A-1E73-8685F24F4C5F}"/>
    <pc:docChg chg="modSld">
      <pc:chgData name="Salim, Chinnu" userId="S::chisalim@iu.edu::97f0121d-12bb-4de1-b0c3-9497d3c11a4c" providerId="AD" clId="Web-{056B5A7F-A37F-BB7A-1E73-8685F24F4C5F}" dt="2024-01-21T20:13:36.368" v="1" actId="20577"/>
      <pc:docMkLst>
        <pc:docMk/>
      </pc:docMkLst>
      <pc:sldChg chg="modSp">
        <pc:chgData name="Salim, Chinnu" userId="S::chisalim@iu.edu::97f0121d-12bb-4de1-b0c3-9497d3c11a4c" providerId="AD" clId="Web-{056B5A7F-A37F-BB7A-1E73-8685F24F4C5F}" dt="2024-01-21T20:13:36.368" v="1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056B5A7F-A37F-BB7A-1E73-8685F24F4C5F}" dt="2024-01-21T20:13:36.368" v="1" actId="20577"/>
          <ac:spMkLst>
            <pc:docMk/>
            <pc:sldMk cId="4017803071" sldId="256"/>
            <ac:spMk id="4" creationId="{F5085EF0-C269-B6AE-F3C2-79DBC2C7AF92}"/>
          </ac:spMkLst>
        </pc:spChg>
      </pc:sldChg>
    </pc:docChg>
  </pc:docChgLst>
  <pc:docChgLst>
    <pc:chgData name="Hundley, Heather Ann" userId="9923bbf4-35ca-4515-b4c1-83653bfb90e1" providerId="ADAL" clId="{23D5CB83-772C-9F4F-9DA7-012FB113E6F3}"/>
    <pc:docChg chg="modSld">
      <pc:chgData name="Hundley, Heather Ann" userId="9923bbf4-35ca-4515-b4c1-83653bfb90e1" providerId="ADAL" clId="{23D5CB83-772C-9F4F-9DA7-012FB113E6F3}" dt="2023-08-07T14:55:19.603" v="8" actId="20577"/>
      <pc:docMkLst>
        <pc:docMk/>
      </pc:docMkLst>
      <pc:sldChg chg="modSp mod">
        <pc:chgData name="Hundley, Heather Ann" userId="9923bbf4-35ca-4515-b4c1-83653bfb90e1" providerId="ADAL" clId="{23D5CB83-772C-9F4F-9DA7-012FB113E6F3}" dt="2023-08-07T14:55:19.603" v="8" actId="20577"/>
        <pc:sldMkLst>
          <pc:docMk/>
          <pc:sldMk cId="4017803071" sldId="256"/>
        </pc:sldMkLst>
        <pc:spChg chg="mod">
          <ac:chgData name="Hundley, Heather Ann" userId="9923bbf4-35ca-4515-b4c1-83653bfb90e1" providerId="ADAL" clId="{23D5CB83-772C-9F4F-9DA7-012FB113E6F3}" dt="2023-08-07T14:55:19.603" v="8" actId="20577"/>
          <ac:spMkLst>
            <pc:docMk/>
            <pc:sldMk cId="4017803071" sldId="256"/>
            <ac:spMk id="4" creationId="{F5085EF0-C269-B6AE-F3C2-79DBC2C7AF92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Salim, Chinnu" userId="S::chisalim@iu.edu::97f0121d-12bb-4de1-b0c3-9497d3c11a4c" providerId="AD" clId="Web-{8A8966A6-916A-CA77-2F3D-D66880EE604A}"/>
    <pc:docChg chg="modSld">
      <pc:chgData name="Salim, Chinnu" userId="S::chisalim@iu.edu::97f0121d-12bb-4de1-b0c3-9497d3c11a4c" providerId="AD" clId="Web-{8A8966A6-916A-CA77-2F3D-D66880EE604A}" dt="2023-08-18T20:19:59.086" v="0" actId="20577"/>
      <pc:docMkLst>
        <pc:docMk/>
      </pc:docMkLst>
      <pc:sldChg chg="modSp">
        <pc:chgData name="Salim, Chinnu" userId="S::chisalim@iu.edu::97f0121d-12bb-4de1-b0c3-9497d3c11a4c" providerId="AD" clId="Web-{8A8966A6-916A-CA77-2F3D-D66880EE604A}" dt="2023-08-18T20:19:59.086" v="0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8A8966A6-916A-CA77-2F3D-D66880EE604A}" dt="2023-08-18T20:19:59.086" v="0" actId="20577"/>
          <ac:spMkLst>
            <pc:docMk/>
            <pc:sldMk cId="4017803071" sldId="256"/>
            <ac:spMk id="4" creationId="{F5085EF0-C269-B6AE-F3C2-79DBC2C7AF92}"/>
          </ac:spMkLst>
        </pc:spChg>
      </pc:sldChg>
    </pc:docChg>
  </pc:docChgLst>
  <pc:docChgLst>
    <pc:chgData name="Salim, Chinnu" userId="S::chisalim@iu.edu::97f0121d-12bb-4de1-b0c3-9497d3c11a4c" providerId="AD" clId="Web-{8973F964-974C-F6A5-6499-99CC6EE8CE3D}"/>
    <pc:docChg chg="modSld">
      <pc:chgData name="Salim, Chinnu" userId="S::chisalim@iu.edu::97f0121d-12bb-4de1-b0c3-9497d3c11a4c" providerId="AD" clId="Web-{8973F964-974C-F6A5-6499-99CC6EE8CE3D}" dt="2023-08-17T13:45:37.527" v="2" actId="20577"/>
      <pc:docMkLst>
        <pc:docMk/>
      </pc:docMkLst>
      <pc:sldChg chg="modSp">
        <pc:chgData name="Salim, Chinnu" userId="S::chisalim@iu.edu::97f0121d-12bb-4de1-b0c3-9497d3c11a4c" providerId="AD" clId="Web-{8973F964-974C-F6A5-6499-99CC6EE8CE3D}" dt="2023-08-17T13:45:37.527" v="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8973F964-974C-F6A5-6499-99CC6EE8CE3D}" dt="2023-08-17T13:45:37.527" v="2" actId="20577"/>
          <ac:spMkLst>
            <pc:docMk/>
            <pc:sldMk cId="4017803071" sldId="256"/>
            <ac:spMk id="4" creationId="{F5085EF0-C269-B6AE-F3C2-79DBC2C7AF9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19D0C4-32CD-1272-4AEF-CB6B76937887}"/>
              </a:ext>
            </a:extLst>
          </p:cNvPr>
          <p:cNvSpPr txBox="1"/>
          <p:nvPr/>
        </p:nvSpPr>
        <p:spPr>
          <a:xfrm>
            <a:off x="250497" y="212899"/>
            <a:ext cx="184731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 descr="A graph of a normal distribution&#10;&#10;Description automatically generated">
            <a:extLst>
              <a:ext uri="{FF2B5EF4-FFF2-40B4-BE49-F238E27FC236}">
                <a16:creationId xmlns:a16="http://schemas.microsoft.com/office/drawing/2014/main" id="{92EF1EF4-C6AA-FDF8-78F7-06536F07E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6105" y="2934"/>
            <a:ext cx="5274695" cy="30311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5085EF0-C269-B6AE-F3C2-79DBC2C7AF92}"/>
              </a:ext>
            </a:extLst>
          </p:cNvPr>
          <p:cNvSpPr txBox="1"/>
          <p:nvPr/>
        </p:nvSpPr>
        <p:spPr>
          <a:xfrm>
            <a:off x="162838" y="2997875"/>
            <a:ext cx="7609562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dditional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ile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18: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ig.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S18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. Loss of </a:t>
            </a:r>
            <a:r>
              <a:rPr lang="en-US" sz="1200" b="1" i="1" u="none" strike="noStrike" dirty="0" err="1">
                <a:solidFill>
                  <a:srgbClr val="000000"/>
                </a:solidFill>
                <a:effectLst/>
                <a:latin typeface="Arial"/>
                <a:cs typeface="Arial"/>
              </a:rPr>
              <a:t>adrs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 results in enhanced susceptibility to several pathogenic bacterial species.</a:t>
            </a:r>
            <a:r>
              <a:rPr lang="en-US" sz="1200" b="1" i="0" u="none" strike="noStrike" dirty="0">
                <a:solidFill>
                  <a:srgbClr val="FF0000"/>
                </a:solidFill>
                <a:effectLst/>
                <a:latin typeface="Arial"/>
                <a:cs typeface="Arial"/>
              </a:rPr>
              <a:t> 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-D) Survival curves for the indicated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 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animals subjected to the slow-killing assay and scored for survival in response to 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S. aureus 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(A,B) and 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S. enterica 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(C,D)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.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 Biological replicates 2 and 3 for the data presented in Figure 5B and C. Statistical significance was determined using OASIS, ****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p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&lt;0.0001, ***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p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/>
                <a:cs typeface="Arial"/>
              </a:rPr>
              <a:t>&lt;0.001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17803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6</TotalTime>
  <Words>8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Salim, Chinnu</cp:lastModifiedBy>
  <cp:revision>86</cp:revision>
  <cp:lastPrinted>2023-01-31T14:45:13Z</cp:lastPrinted>
  <dcterms:created xsi:type="dcterms:W3CDTF">2022-10-06T21:20:44Z</dcterms:created>
  <dcterms:modified xsi:type="dcterms:W3CDTF">2024-01-21T20:13:42Z</dcterms:modified>
</cp:coreProperties>
</file>